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60" r:id="rId4"/>
    <p:sldId id="261" r:id="rId5"/>
  </p:sldIdLst>
  <p:sldSz cx="7556500" cy="106934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15.png"/><Relationship Id="rId7" Type="http://schemas.openxmlformats.org/officeDocument/2006/relationships/image" Target="../media/image14.png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15.png"/><Relationship Id="rId7" Type="http://schemas.openxmlformats.org/officeDocument/2006/relationships/image" Target="../media/image14.png"/><Relationship Id="rId6" Type="http://schemas.openxmlformats.org/officeDocument/2006/relationships/image" Target="../media/image13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2026138" y="3731732"/>
            <a:ext cx="1544170" cy="284105"/>
          </a:xfrm>
          <a:prstGeom prst="rect">
            <a:avLst/>
          </a:prstGeom>
        </p:spPr>
      </p:pic>
      <p:sp>
        <p:nvSpPr>
          <p:cNvPr id="4" name="path"/>
          <p:cNvSpPr/>
          <p:nvPr/>
        </p:nvSpPr>
        <p:spPr>
          <a:xfrm>
            <a:off x="2044196" y="1232341"/>
            <a:ext cx="334312" cy="2537122"/>
          </a:xfrm>
          <a:custGeom>
            <a:avLst/>
            <a:gdLst/>
            <a:ahLst/>
            <a:cxnLst/>
            <a:rect l="0" t="0" r="0" b="0"/>
            <a:pathLst>
              <a:path w="526" h="3995">
                <a:moveTo>
                  <a:pt x="7" y="3943"/>
                </a:moveTo>
                <a:lnTo>
                  <a:pt x="35" y="3815"/>
                </a:lnTo>
                <a:lnTo>
                  <a:pt x="64" y="3652"/>
                </a:lnTo>
                <a:lnTo>
                  <a:pt x="92" y="3475"/>
                </a:lnTo>
                <a:lnTo>
                  <a:pt x="121" y="3292"/>
                </a:lnTo>
                <a:lnTo>
                  <a:pt x="149" y="3041"/>
                </a:lnTo>
                <a:lnTo>
                  <a:pt x="177" y="2787"/>
                </a:lnTo>
                <a:lnTo>
                  <a:pt x="206" y="2552"/>
                </a:lnTo>
                <a:lnTo>
                  <a:pt x="234" y="2011"/>
                </a:lnTo>
                <a:lnTo>
                  <a:pt x="263" y="1163"/>
                </a:lnTo>
                <a:lnTo>
                  <a:pt x="291" y="235"/>
                </a:lnTo>
                <a:lnTo>
                  <a:pt x="320" y="7"/>
                </a:lnTo>
                <a:lnTo>
                  <a:pt x="348" y="564"/>
                </a:lnTo>
                <a:lnTo>
                  <a:pt x="376" y="1370"/>
                </a:lnTo>
                <a:lnTo>
                  <a:pt x="405" y="2342"/>
                </a:lnTo>
                <a:lnTo>
                  <a:pt x="433" y="3061"/>
                </a:lnTo>
                <a:lnTo>
                  <a:pt x="462" y="3494"/>
                </a:lnTo>
                <a:lnTo>
                  <a:pt x="490" y="3788"/>
                </a:lnTo>
                <a:lnTo>
                  <a:pt x="519" y="3988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" name="path"/>
          <p:cNvSpPr/>
          <p:nvPr/>
        </p:nvSpPr>
        <p:spPr>
          <a:xfrm>
            <a:off x="924574" y="3710164"/>
            <a:ext cx="3620944" cy="195615"/>
          </a:xfrm>
          <a:custGeom>
            <a:avLst/>
            <a:gdLst/>
            <a:ahLst/>
            <a:cxnLst/>
            <a:rect l="0" t="0" r="0" b="0"/>
            <a:pathLst>
              <a:path w="5702" h="308">
                <a:moveTo>
                  <a:pt x="7" y="300"/>
                </a:moveTo>
                <a:lnTo>
                  <a:pt x="35" y="300"/>
                </a:lnTo>
                <a:lnTo>
                  <a:pt x="64" y="300"/>
                </a:lnTo>
                <a:lnTo>
                  <a:pt x="92" y="300"/>
                </a:lnTo>
                <a:lnTo>
                  <a:pt x="121" y="300"/>
                </a:lnTo>
                <a:lnTo>
                  <a:pt x="149" y="300"/>
                </a:lnTo>
                <a:lnTo>
                  <a:pt x="177" y="300"/>
                </a:lnTo>
                <a:lnTo>
                  <a:pt x="206" y="300"/>
                </a:lnTo>
                <a:lnTo>
                  <a:pt x="234" y="300"/>
                </a:lnTo>
                <a:lnTo>
                  <a:pt x="263" y="300"/>
                </a:lnTo>
                <a:lnTo>
                  <a:pt x="291" y="300"/>
                </a:lnTo>
                <a:lnTo>
                  <a:pt x="320" y="300"/>
                </a:lnTo>
                <a:lnTo>
                  <a:pt x="348" y="300"/>
                </a:lnTo>
                <a:lnTo>
                  <a:pt x="376" y="300"/>
                </a:lnTo>
                <a:lnTo>
                  <a:pt x="405" y="300"/>
                </a:lnTo>
                <a:lnTo>
                  <a:pt x="433" y="300"/>
                </a:lnTo>
                <a:lnTo>
                  <a:pt x="462" y="300"/>
                </a:lnTo>
                <a:lnTo>
                  <a:pt x="490" y="300"/>
                </a:lnTo>
                <a:lnTo>
                  <a:pt x="519" y="300"/>
                </a:lnTo>
                <a:lnTo>
                  <a:pt x="547" y="300"/>
                </a:lnTo>
                <a:lnTo>
                  <a:pt x="576" y="300"/>
                </a:lnTo>
                <a:lnTo>
                  <a:pt x="604" y="300"/>
                </a:lnTo>
                <a:lnTo>
                  <a:pt x="632" y="300"/>
                </a:lnTo>
                <a:lnTo>
                  <a:pt x="661" y="300"/>
                </a:lnTo>
                <a:lnTo>
                  <a:pt x="689" y="300"/>
                </a:lnTo>
                <a:lnTo>
                  <a:pt x="718" y="300"/>
                </a:lnTo>
                <a:lnTo>
                  <a:pt x="746" y="300"/>
                </a:lnTo>
                <a:lnTo>
                  <a:pt x="775" y="300"/>
                </a:lnTo>
                <a:lnTo>
                  <a:pt x="803" y="300"/>
                </a:lnTo>
                <a:lnTo>
                  <a:pt x="832" y="300"/>
                </a:lnTo>
                <a:lnTo>
                  <a:pt x="860" y="300"/>
                </a:lnTo>
                <a:lnTo>
                  <a:pt x="888" y="300"/>
                </a:lnTo>
                <a:lnTo>
                  <a:pt x="917" y="300"/>
                </a:lnTo>
                <a:lnTo>
                  <a:pt x="945" y="300"/>
                </a:lnTo>
                <a:lnTo>
                  <a:pt x="974" y="300"/>
                </a:lnTo>
                <a:lnTo>
                  <a:pt x="1002" y="300"/>
                </a:lnTo>
                <a:lnTo>
                  <a:pt x="1031" y="300"/>
                </a:lnTo>
                <a:lnTo>
                  <a:pt x="1059" y="300"/>
                </a:lnTo>
                <a:lnTo>
                  <a:pt x="1087" y="300"/>
                </a:lnTo>
                <a:lnTo>
                  <a:pt x="1116" y="300"/>
                </a:lnTo>
                <a:lnTo>
                  <a:pt x="1144" y="300"/>
                </a:lnTo>
                <a:lnTo>
                  <a:pt x="1173" y="300"/>
                </a:lnTo>
                <a:lnTo>
                  <a:pt x="1201" y="300"/>
                </a:lnTo>
                <a:lnTo>
                  <a:pt x="1230" y="300"/>
                </a:lnTo>
                <a:lnTo>
                  <a:pt x="1258" y="300"/>
                </a:lnTo>
                <a:lnTo>
                  <a:pt x="1287" y="300"/>
                </a:lnTo>
                <a:lnTo>
                  <a:pt x="1315" y="300"/>
                </a:lnTo>
                <a:lnTo>
                  <a:pt x="1343" y="300"/>
                </a:lnTo>
                <a:lnTo>
                  <a:pt x="1372" y="300"/>
                </a:lnTo>
                <a:lnTo>
                  <a:pt x="1400" y="296"/>
                </a:lnTo>
                <a:lnTo>
                  <a:pt x="1429" y="298"/>
                </a:lnTo>
                <a:lnTo>
                  <a:pt x="1457" y="295"/>
                </a:lnTo>
                <a:lnTo>
                  <a:pt x="1486" y="296"/>
                </a:lnTo>
                <a:lnTo>
                  <a:pt x="1514" y="293"/>
                </a:lnTo>
                <a:lnTo>
                  <a:pt x="1542" y="293"/>
                </a:lnTo>
                <a:lnTo>
                  <a:pt x="1571" y="295"/>
                </a:lnTo>
                <a:lnTo>
                  <a:pt x="1599" y="293"/>
                </a:lnTo>
                <a:lnTo>
                  <a:pt x="1628" y="288"/>
                </a:lnTo>
                <a:lnTo>
                  <a:pt x="1656" y="288"/>
                </a:lnTo>
                <a:lnTo>
                  <a:pt x="1685" y="250"/>
                </a:lnTo>
                <a:lnTo>
                  <a:pt x="1713" y="211"/>
                </a:lnTo>
                <a:lnTo>
                  <a:pt x="1742" y="140"/>
                </a:lnTo>
                <a:moveTo>
                  <a:pt x="2282" y="86"/>
                </a:moveTo>
                <a:lnTo>
                  <a:pt x="2310" y="130"/>
                </a:lnTo>
                <a:lnTo>
                  <a:pt x="2339" y="162"/>
                </a:lnTo>
                <a:lnTo>
                  <a:pt x="2367" y="170"/>
                </a:lnTo>
                <a:lnTo>
                  <a:pt x="2396" y="211"/>
                </a:lnTo>
                <a:lnTo>
                  <a:pt x="2424" y="186"/>
                </a:lnTo>
                <a:lnTo>
                  <a:pt x="2452" y="196"/>
                </a:lnTo>
                <a:lnTo>
                  <a:pt x="2481" y="215"/>
                </a:lnTo>
                <a:lnTo>
                  <a:pt x="2509" y="220"/>
                </a:lnTo>
                <a:lnTo>
                  <a:pt x="2538" y="228"/>
                </a:lnTo>
                <a:lnTo>
                  <a:pt x="2566" y="223"/>
                </a:lnTo>
                <a:lnTo>
                  <a:pt x="2595" y="226"/>
                </a:lnTo>
                <a:lnTo>
                  <a:pt x="2623" y="227"/>
                </a:lnTo>
                <a:lnTo>
                  <a:pt x="2652" y="242"/>
                </a:lnTo>
                <a:lnTo>
                  <a:pt x="2680" y="198"/>
                </a:lnTo>
                <a:lnTo>
                  <a:pt x="2708" y="207"/>
                </a:lnTo>
                <a:lnTo>
                  <a:pt x="2737" y="221"/>
                </a:lnTo>
                <a:lnTo>
                  <a:pt x="2765" y="213"/>
                </a:lnTo>
                <a:lnTo>
                  <a:pt x="2794" y="211"/>
                </a:lnTo>
                <a:lnTo>
                  <a:pt x="2822" y="221"/>
                </a:lnTo>
                <a:lnTo>
                  <a:pt x="2851" y="212"/>
                </a:lnTo>
                <a:lnTo>
                  <a:pt x="2879" y="226"/>
                </a:lnTo>
                <a:lnTo>
                  <a:pt x="2908" y="220"/>
                </a:lnTo>
                <a:lnTo>
                  <a:pt x="2936" y="220"/>
                </a:lnTo>
                <a:lnTo>
                  <a:pt x="2964" y="226"/>
                </a:lnTo>
                <a:lnTo>
                  <a:pt x="2993" y="215"/>
                </a:lnTo>
                <a:lnTo>
                  <a:pt x="3021" y="232"/>
                </a:lnTo>
                <a:lnTo>
                  <a:pt x="3050" y="240"/>
                </a:lnTo>
                <a:lnTo>
                  <a:pt x="3078" y="220"/>
                </a:lnTo>
                <a:lnTo>
                  <a:pt x="3107" y="228"/>
                </a:lnTo>
                <a:lnTo>
                  <a:pt x="3135" y="217"/>
                </a:lnTo>
                <a:lnTo>
                  <a:pt x="3163" y="227"/>
                </a:lnTo>
                <a:lnTo>
                  <a:pt x="3192" y="232"/>
                </a:lnTo>
                <a:lnTo>
                  <a:pt x="3220" y="226"/>
                </a:lnTo>
                <a:lnTo>
                  <a:pt x="3249" y="219"/>
                </a:lnTo>
                <a:lnTo>
                  <a:pt x="3277" y="235"/>
                </a:lnTo>
                <a:lnTo>
                  <a:pt x="3306" y="213"/>
                </a:lnTo>
                <a:lnTo>
                  <a:pt x="3334" y="224"/>
                </a:lnTo>
                <a:lnTo>
                  <a:pt x="3363" y="207"/>
                </a:lnTo>
                <a:lnTo>
                  <a:pt x="3391" y="221"/>
                </a:lnTo>
                <a:lnTo>
                  <a:pt x="3419" y="230"/>
                </a:lnTo>
                <a:lnTo>
                  <a:pt x="3448" y="211"/>
                </a:lnTo>
                <a:lnTo>
                  <a:pt x="3476" y="220"/>
                </a:lnTo>
                <a:lnTo>
                  <a:pt x="3505" y="175"/>
                </a:lnTo>
                <a:lnTo>
                  <a:pt x="3533" y="181"/>
                </a:lnTo>
                <a:lnTo>
                  <a:pt x="3562" y="183"/>
                </a:lnTo>
                <a:lnTo>
                  <a:pt x="3590" y="174"/>
                </a:lnTo>
                <a:lnTo>
                  <a:pt x="3618" y="183"/>
                </a:lnTo>
                <a:lnTo>
                  <a:pt x="3647" y="170"/>
                </a:lnTo>
                <a:lnTo>
                  <a:pt x="3675" y="187"/>
                </a:lnTo>
                <a:lnTo>
                  <a:pt x="3704" y="132"/>
                </a:lnTo>
                <a:lnTo>
                  <a:pt x="3732" y="171"/>
                </a:lnTo>
                <a:lnTo>
                  <a:pt x="3761" y="148"/>
                </a:lnTo>
                <a:lnTo>
                  <a:pt x="3789" y="130"/>
                </a:lnTo>
                <a:lnTo>
                  <a:pt x="3818" y="110"/>
                </a:lnTo>
                <a:lnTo>
                  <a:pt x="3846" y="105"/>
                </a:lnTo>
                <a:lnTo>
                  <a:pt x="3874" y="118"/>
                </a:lnTo>
                <a:lnTo>
                  <a:pt x="3903" y="90"/>
                </a:lnTo>
                <a:lnTo>
                  <a:pt x="3931" y="50"/>
                </a:lnTo>
                <a:lnTo>
                  <a:pt x="3960" y="34"/>
                </a:lnTo>
                <a:lnTo>
                  <a:pt x="3988" y="53"/>
                </a:lnTo>
                <a:lnTo>
                  <a:pt x="4017" y="22"/>
                </a:lnTo>
                <a:lnTo>
                  <a:pt x="4045" y="18"/>
                </a:lnTo>
                <a:lnTo>
                  <a:pt x="4073" y="7"/>
                </a:lnTo>
                <a:lnTo>
                  <a:pt x="4102" y="42"/>
                </a:lnTo>
                <a:lnTo>
                  <a:pt x="4130" y="67"/>
                </a:lnTo>
                <a:lnTo>
                  <a:pt x="4159" y="103"/>
                </a:lnTo>
                <a:lnTo>
                  <a:pt x="4187" y="154"/>
                </a:lnTo>
                <a:lnTo>
                  <a:pt x="4216" y="168"/>
                </a:lnTo>
                <a:lnTo>
                  <a:pt x="4244" y="219"/>
                </a:lnTo>
                <a:lnTo>
                  <a:pt x="4273" y="242"/>
                </a:lnTo>
                <a:lnTo>
                  <a:pt x="4301" y="264"/>
                </a:lnTo>
                <a:lnTo>
                  <a:pt x="4329" y="260"/>
                </a:lnTo>
                <a:lnTo>
                  <a:pt x="4358" y="280"/>
                </a:lnTo>
                <a:lnTo>
                  <a:pt x="4386" y="284"/>
                </a:lnTo>
                <a:lnTo>
                  <a:pt x="4415" y="296"/>
                </a:lnTo>
                <a:lnTo>
                  <a:pt x="4443" y="293"/>
                </a:lnTo>
                <a:lnTo>
                  <a:pt x="4472" y="292"/>
                </a:lnTo>
                <a:lnTo>
                  <a:pt x="4500" y="295"/>
                </a:lnTo>
                <a:lnTo>
                  <a:pt x="4529" y="296"/>
                </a:lnTo>
                <a:lnTo>
                  <a:pt x="4557" y="300"/>
                </a:lnTo>
                <a:lnTo>
                  <a:pt x="4585" y="296"/>
                </a:lnTo>
                <a:lnTo>
                  <a:pt x="4614" y="300"/>
                </a:lnTo>
                <a:lnTo>
                  <a:pt x="4642" y="295"/>
                </a:lnTo>
                <a:lnTo>
                  <a:pt x="4671" y="300"/>
                </a:lnTo>
                <a:lnTo>
                  <a:pt x="4699" y="293"/>
                </a:lnTo>
                <a:lnTo>
                  <a:pt x="4728" y="300"/>
                </a:lnTo>
                <a:lnTo>
                  <a:pt x="4756" y="300"/>
                </a:lnTo>
                <a:lnTo>
                  <a:pt x="4784" y="298"/>
                </a:lnTo>
                <a:lnTo>
                  <a:pt x="4813" y="300"/>
                </a:lnTo>
                <a:lnTo>
                  <a:pt x="4841" y="295"/>
                </a:lnTo>
                <a:lnTo>
                  <a:pt x="4870" y="300"/>
                </a:lnTo>
                <a:lnTo>
                  <a:pt x="4898" y="300"/>
                </a:lnTo>
                <a:lnTo>
                  <a:pt x="4927" y="299"/>
                </a:lnTo>
                <a:lnTo>
                  <a:pt x="4955" y="299"/>
                </a:lnTo>
                <a:lnTo>
                  <a:pt x="4984" y="296"/>
                </a:lnTo>
                <a:lnTo>
                  <a:pt x="5012" y="299"/>
                </a:lnTo>
                <a:lnTo>
                  <a:pt x="5040" y="299"/>
                </a:lnTo>
                <a:lnTo>
                  <a:pt x="5069" y="300"/>
                </a:lnTo>
                <a:lnTo>
                  <a:pt x="5097" y="300"/>
                </a:lnTo>
                <a:lnTo>
                  <a:pt x="5126" y="300"/>
                </a:lnTo>
                <a:lnTo>
                  <a:pt x="5154" y="300"/>
                </a:lnTo>
                <a:lnTo>
                  <a:pt x="5183" y="300"/>
                </a:lnTo>
                <a:lnTo>
                  <a:pt x="5211" y="300"/>
                </a:lnTo>
                <a:lnTo>
                  <a:pt x="5239" y="300"/>
                </a:lnTo>
                <a:lnTo>
                  <a:pt x="5268" y="299"/>
                </a:lnTo>
                <a:lnTo>
                  <a:pt x="5296" y="300"/>
                </a:lnTo>
                <a:lnTo>
                  <a:pt x="5325" y="300"/>
                </a:lnTo>
                <a:lnTo>
                  <a:pt x="5353" y="300"/>
                </a:lnTo>
                <a:lnTo>
                  <a:pt x="5382" y="300"/>
                </a:lnTo>
                <a:lnTo>
                  <a:pt x="5410" y="300"/>
                </a:lnTo>
                <a:lnTo>
                  <a:pt x="5439" y="300"/>
                </a:lnTo>
                <a:lnTo>
                  <a:pt x="5467" y="300"/>
                </a:lnTo>
                <a:lnTo>
                  <a:pt x="5495" y="300"/>
                </a:lnTo>
                <a:lnTo>
                  <a:pt x="5524" y="300"/>
                </a:lnTo>
                <a:lnTo>
                  <a:pt x="5552" y="300"/>
                </a:lnTo>
                <a:lnTo>
                  <a:pt x="5581" y="300"/>
                </a:lnTo>
                <a:lnTo>
                  <a:pt x="5609" y="300"/>
                </a:lnTo>
                <a:lnTo>
                  <a:pt x="5638" y="300"/>
                </a:lnTo>
                <a:lnTo>
                  <a:pt x="5666" y="300"/>
                </a:lnTo>
                <a:lnTo>
                  <a:pt x="5694" y="300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" name="path"/>
          <p:cNvSpPr/>
          <p:nvPr/>
        </p:nvSpPr>
        <p:spPr>
          <a:xfrm>
            <a:off x="915387" y="3900191"/>
            <a:ext cx="7123" cy="135349"/>
          </a:xfrm>
          <a:custGeom>
            <a:avLst/>
            <a:gdLst/>
            <a:ahLst/>
            <a:cxnLst/>
            <a:rect l="0" t="0" r="0" b="0"/>
            <a:pathLst>
              <a:path w="11" h="213">
                <a:moveTo>
                  <a:pt x="5" y="5"/>
                </a:moveTo>
                <a:lnTo>
                  <a:pt x="5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" name="path"/>
          <p:cNvSpPr/>
          <p:nvPr/>
        </p:nvSpPr>
        <p:spPr>
          <a:xfrm>
            <a:off x="1093478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" name="path"/>
          <p:cNvSpPr/>
          <p:nvPr/>
        </p:nvSpPr>
        <p:spPr>
          <a:xfrm>
            <a:off x="1998180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" name="path"/>
          <p:cNvSpPr/>
          <p:nvPr/>
        </p:nvSpPr>
        <p:spPr>
          <a:xfrm>
            <a:off x="2902882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" name="path"/>
          <p:cNvSpPr/>
          <p:nvPr/>
        </p:nvSpPr>
        <p:spPr>
          <a:xfrm>
            <a:off x="3807583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" name="path"/>
          <p:cNvSpPr/>
          <p:nvPr/>
        </p:nvSpPr>
        <p:spPr>
          <a:xfrm>
            <a:off x="915387" y="3900191"/>
            <a:ext cx="3625931" cy="7123"/>
          </a:xfrm>
          <a:custGeom>
            <a:avLst/>
            <a:gdLst/>
            <a:ahLst/>
            <a:cxnLst/>
            <a:rect l="0" t="0" r="0" b="0"/>
            <a:pathLst>
              <a:path w="5710" h="11">
                <a:moveTo>
                  <a:pt x="5" y="5"/>
                </a:moveTo>
                <a:lnTo>
                  <a:pt x="5704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20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679037"/>
            <a:ext cx="3611684" cy="2222111"/>
          </a:xfrm>
          <a:prstGeom prst="rect">
            <a:avLst/>
          </a:prstGeom>
        </p:spPr>
      </p:pic>
      <p:sp>
        <p:nvSpPr>
          <p:cNvPr id="22" name="textbox 22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74000"/>
              </a:lnSpc>
            </a:pPr>
            <a:endParaRPr lang="en-US" altLang="en-US" sz="100" dirty="0"/>
          </a:p>
          <a:p>
            <a:pPr marL="21590" algn="l" rtl="0" eaLnBrk="0">
              <a:lnSpc>
                <a:spcPct val="9700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_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_010.fcs</a:t>
            </a:r>
            <a:r>
              <a:rPr sz="10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lang="en-US" altLang="en-US" sz="900" dirty="0"/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lang="en-US" altLang="en-US" sz="1000" dirty="0"/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lang="en-US" altLang="en-US" sz="1000" dirty="0"/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lang="en-US" altLang="en-US" sz="900" dirty="0"/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6.5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89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0.63</a:t>
            </a:r>
            <a:endParaRPr lang="en-US" altLang="en-US" sz="900" dirty="0"/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.5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lang="en-US" altLang="en-US" sz="900" dirty="0"/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69</a:t>
            </a:r>
            <a:endParaRPr lang="en-US" altLang="en-US" sz="1000" dirty="0"/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.5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lang="en-US" altLang="en-US" sz="900" dirty="0"/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231</a:t>
            </a:r>
            <a:endParaRPr lang="en-US" altLang="en-US" sz="9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231</a:t>
            </a:r>
            <a:endParaRPr lang="en-US" altLang="en-US" sz="1000" dirty="0"/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6</a:t>
            </a:r>
            <a:endParaRPr lang="en-US" altLang="en-US" sz="900" dirty="0"/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.286</a:t>
            </a:r>
            <a:endParaRPr lang="en-US" altLang="en-US" sz="900" dirty="0"/>
          </a:p>
        </p:txBody>
      </p:sp>
      <p:pic>
        <p:nvPicPr>
          <p:cNvPr id="24" name="picture 2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pic>
        <p:nvPicPr>
          <p:cNvPr id="26" name="picture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pic>
        <p:nvPicPr>
          <p:cNvPr id="28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sp>
        <p:nvSpPr>
          <p:cNvPr id="30" name="textbox 30"/>
          <p:cNvSpPr/>
          <p:nvPr/>
        </p:nvSpPr>
        <p:spPr>
          <a:xfrm>
            <a:off x="882499" y="4078020"/>
            <a:ext cx="3767454" cy="30352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lang="en-US" altLang="en-US" sz="900" dirty="0"/>
          </a:p>
          <a:p>
            <a:pPr algn="l" rtl="0" eaLnBrk="0">
              <a:lnSpc>
                <a:spcPct val="105000"/>
              </a:lnSpc>
            </a:pPr>
            <a:endParaRPr lang="en-US" altLang="en-US" sz="300" dirty="0"/>
          </a:p>
          <a:p>
            <a:pPr marL="1741170" algn="l" rtl="0" eaLnBrk="0">
              <a:lnSpc>
                <a:spcPct val="78000"/>
              </a:lnSpc>
              <a:spcBef>
                <a:spcPts val="0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sp>
        <p:nvSpPr>
          <p:cNvPr id="32" name="path"/>
          <p:cNvSpPr/>
          <p:nvPr/>
        </p:nvSpPr>
        <p:spPr>
          <a:xfrm>
            <a:off x="5766746" y="7963434"/>
            <a:ext cx="675964" cy="598187"/>
          </a:xfrm>
          <a:custGeom>
            <a:avLst/>
            <a:gdLst/>
            <a:ahLst/>
            <a:cxnLst/>
            <a:rect l="0" t="0" r="0" b="0"/>
            <a:pathLst>
              <a:path w="1064" h="942">
                <a:moveTo>
                  <a:pt x="928" y="21"/>
                </a:moveTo>
                <a:lnTo>
                  <a:pt x="986" y="72"/>
                </a:lnTo>
                <a:lnTo>
                  <a:pt x="1047" y="132"/>
                </a:lnTo>
                <a:moveTo>
                  <a:pt x="400" y="925"/>
                </a:moveTo>
                <a:lnTo>
                  <a:pt x="329" y="916"/>
                </a:lnTo>
                <a:lnTo>
                  <a:pt x="259" y="895"/>
                </a:lnTo>
                <a:lnTo>
                  <a:pt x="193" y="860"/>
                </a:lnTo>
                <a:lnTo>
                  <a:pt x="140" y="813"/>
                </a:lnTo>
                <a:lnTo>
                  <a:pt x="78" y="766"/>
                </a:lnTo>
                <a:lnTo>
                  <a:pt x="30" y="706"/>
                </a:lnTo>
                <a:lnTo>
                  <a:pt x="16" y="638"/>
                </a:lnTo>
                <a:lnTo>
                  <a:pt x="21" y="569"/>
                </a:lnTo>
                <a:lnTo>
                  <a:pt x="43" y="501"/>
                </a:lnTo>
                <a:lnTo>
                  <a:pt x="69" y="436"/>
                </a:lnTo>
                <a:lnTo>
                  <a:pt x="100" y="372"/>
                </a:lnTo>
                <a:lnTo>
                  <a:pt x="144" y="312"/>
                </a:lnTo>
                <a:lnTo>
                  <a:pt x="201" y="248"/>
                </a:lnTo>
                <a:lnTo>
                  <a:pt x="259" y="205"/>
                </a:lnTo>
                <a:lnTo>
                  <a:pt x="316" y="162"/>
                </a:lnTo>
                <a:lnTo>
                  <a:pt x="382" y="132"/>
                </a:lnTo>
                <a:lnTo>
                  <a:pt x="452" y="98"/>
                </a:lnTo>
                <a:lnTo>
                  <a:pt x="519" y="68"/>
                </a:lnTo>
                <a:lnTo>
                  <a:pt x="589" y="42"/>
                </a:lnTo>
                <a:lnTo>
                  <a:pt x="660" y="21"/>
                </a:lnTo>
                <a:lnTo>
                  <a:pt x="673" y="16"/>
                </a:lnTo>
                <a:lnTo>
                  <a:pt x="737" y="17"/>
                </a:lnTo>
                <a:lnTo>
                  <a:pt x="800" y="18"/>
                </a:lnTo>
                <a:lnTo>
                  <a:pt x="864" y="20"/>
                </a:lnTo>
                <a:lnTo>
                  <a:pt x="928" y="21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3" name="group 2"/>
          <p:cNvGrpSpPr/>
          <p:nvPr/>
        </p:nvGrpSpPr>
        <p:grpSpPr>
          <a:xfrm rot="21600000">
            <a:off x="758667" y="8053271"/>
            <a:ext cx="1059227" cy="327687"/>
            <a:chOff x="0" y="0"/>
            <a:chExt cx="1059227" cy="327687"/>
          </a:xfrm>
        </p:grpSpPr>
        <p:sp>
          <p:nvSpPr>
            <p:cNvPr id="34" name="path"/>
            <p:cNvSpPr/>
            <p:nvPr/>
          </p:nvSpPr>
          <p:spPr>
            <a:xfrm>
              <a:off x="0" y="0"/>
              <a:ext cx="121101" cy="327687"/>
            </a:xfrm>
            <a:custGeom>
              <a:avLst/>
              <a:gdLst/>
              <a:ahLst/>
              <a:cxnLst/>
              <a:rect l="0" t="0" r="0" b="0"/>
              <a:pathLst>
                <a:path w="190" h="516">
                  <a:moveTo>
                    <a:pt x="185" y="510"/>
                  </a:moveTo>
                  <a:lnTo>
                    <a:pt x="95" y="510"/>
                  </a:lnTo>
                  <a:moveTo>
                    <a:pt x="185" y="443"/>
                  </a:moveTo>
                  <a:lnTo>
                    <a:pt x="95" y="443"/>
                  </a:lnTo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36" name="path"/>
            <p:cNvSpPr/>
            <p:nvPr/>
          </p:nvSpPr>
          <p:spPr>
            <a:xfrm>
              <a:off x="407932" y="382"/>
              <a:ext cx="651294" cy="325403"/>
            </a:xfrm>
            <a:custGeom>
              <a:avLst/>
              <a:gdLst/>
              <a:ahLst/>
              <a:cxnLst/>
              <a:rect l="0" t="0" r="0" b="0"/>
              <a:pathLst>
                <a:path w="1025" h="512">
                  <a:moveTo>
                    <a:pt x="663" y="35"/>
                  </a:moveTo>
                  <a:lnTo>
                    <a:pt x="732" y="25"/>
                  </a:lnTo>
                  <a:lnTo>
                    <a:pt x="822" y="16"/>
                  </a:lnTo>
                  <a:lnTo>
                    <a:pt x="902" y="20"/>
                  </a:lnTo>
                  <a:lnTo>
                    <a:pt x="964" y="42"/>
                  </a:lnTo>
                  <a:lnTo>
                    <a:pt x="995" y="96"/>
                  </a:lnTo>
                  <a:lnTo>
                    <a:pt x="1008" y="159"/>
                  </a:lnTo>
                  <a:lnTo>
                    <a:pt x="1006" y="225"/>
                  </a:lnTo>
                  <a:lnTo>
                    <a:pt x="962" y="281"/>
                  </a:lnTo>
                  <a:lnTo>
                    <a:pt x="904" y="320"/>
                  </a:lnTo>
                  <a:lnTo>
                    <a:pt x="849" y="350"/>
                  </a:lnTo>
                  <a:lnTo>
                    <a:pt x="782" y="375"/>
                  </a:lnTo>
                  <a:lnTo>
                    <a:pt x="709" y="397"/>
                  </a:lnTo>
                  <a:lnTo>
                    <a:pt x="626" y="420"/>
                  </a:lnTo>
                  <a:lnTo>
                    <a:pt x="557" y="441"/>
                  </a:lnTo>
                  <a:lnTo>
                    <a:pt x="493" y="458"/>
                  </a:lnTo>
                  <a:lnTo>
                    <a:pt x="432" y="474"/>
                  </a:lnTo>
                  <a:lnTo>
                    <a:pt x="366" y="484"/>
                  </a:lnTo>
                  <a:lnTo>
                    <a:pt x="296" y="493"/>
                  </a:lnTo>
                  <a:lnTo>
                    <a:pt x="229" y="495"/>
                  </a:lnTo>
                  <a:lnTo>
                    <a:pt x="160" y="486"/>
                  </a:lnTo>
                  <a:lnTo>
                    <a:pt x="99" y="471"/>
                  </a:lnTo>
                  <a:lnTo>
                    <a:pt x="49" y="424"/>
                  </a:lnTo>
                  <a:lnTo>
                    <a:pt x="21" y="367"/>
                  </a:lnTo>
                  <a:lnTo>
                    <a:pt x="16" y="306"/>
                  </a:lnTo>
                  <a:lnTo>
                    <a:pt x="47" y="241"/>
                  </a:lnTo>
                  <a:lnTo>
                    <a:pt x="100" y="195"/>
                  </a:lnTo>
                  <a:lnTo>
                    <a:pt x="154" y="160"/>
                  </a:lnTo>
                  <a:lnTo>
                    <a:pt x="222" y="135"/>
                  </a:lnTo>
                  <a:lnTo>
                    <a:pt x="286" y="111"/>
                  </a:lnTo>
                  <a:lnTo>
                    <a:pt x="347" y="98"/>
                  </a:lnTo>
                  <a:lnTo>
                    <a:pt x="410" y="86"/>
                  </a:lnTo>
                  <a:lnTo>
                    <a:pt x="473" y="73"/>
                  </a:lnTo>
                  <a:lnTo>
                    <a:pt x="536" y="60"/>
                  </a:lnTo>
                  <a:lnTo>
                    <a:pt x="599" y="48"/>
                  </a:lnTo>
                  <a:lnTo>
                    <a:pt x="663" y="35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38" name="textbox 3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0" name="textbox 4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2" name="textbox 42"/>
          <p:cNvSpPr/>
          <p:nvPr/>
        </p:nvSpPr>
        <p:spPr>
          <a:xfrm>
            <a:off x="5519459" y="8760429"/>
            <a:ext cx="1303019" cy="28765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02000"/>
              </a:lnSpc>
            </a:pPr>
            <a:endParaRPr lang="en-US" altLang="en-US" sz="300" dirty="0"/>
          </a:p>
          <a:p>
            <a:pPr marL="537845" algn="l" rtl="0" eaLnBrk="0">
              <a:lnSpc>
                <a:spcPct val="78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grpSp>
        <p:nvGrpSpPr>
          <p:cNvPr id="5" name="group 4"/>
          <p:cNvGrpSpPr/>
          <p:nvPr/>
        </p:nvGrpSpPr>
        <p:grpSpPr>
          <a:xfrm rot="21600000">
            <a:off x="3095220" y="8053271"/>
            <a:ext cx="1097580" cy="266195"/>
            <a:chOff x="0" y="0"/>
            <a:chExt cx="1097580" cy="266195"/>
          </a:xfrm>
        </p:grpSpPr>
        <p:sp>
          <p:nvSpPr>
            <p:cNvPr id="44" name="path"/>
            <p:cNvSpPr/>
            <p:nvPr/>
          </p:nvSpPr>
          <p:spPr>
            <a:xfrm>
              <a:off x="0" y="0"/>
              <a:ext cx="121101" cy="235080"/>
            </a:xfrm>
            <a:custGeom>
              <a:avLst/>
              <a:gdLst/>
              <a:ahLst/>
              <a:cxnLst/>
              <a:rect l="0" t="0" r="0" b="0"/>
              <a:pathLst>
                <a:path w="190" h="370"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6" name="path"/>
            <p:cNvSpPr/>
            <p:nvPr/>
          </p:nvSpPr>
          <p:spPr>
            <a:xfrm>
              <a:off x="418818" y="8112"/>
              <a:ext cx="678762" cy="258083"/>
            </a:xfrm>
            <a:custGeom>
              <a:avLst/>
              <a:gdLst/>
              <a:ahLst/>
              <a:cxnLst/>
              <a:rect l="0" t="0" r="0" b="0"/>
              <a:pathLst>
                <a:path w="1068" h="406">
                  <a:moveTo>
                    <a:pt x="1016" y="76"/>
                  </a:moveTo>
                  <a:lnTo>
                    <a:pt x="1038" y="153"/>
                  </a:lnTo>
                  <a:lnTo>
                    <a:pt x="1052" y="222"/>
                  </a:lnTo>
                  <a:lnTo>
                    <a:pt x="1052" y="267"/>
                  </a:lnTo>
                  <a:lnTo>
                    <a:pt x="1052" y="312"/>
                  </a:lnTo>
                  <a:lnTo>
                    <a:pt x="1047" y="389"/>
                  </a:lnTo>
                  <a:moveTo>
                    <a:pt x="16" y="381"/>
                  </a:moveTo>
                  <a:lnTo>
                    <a:pt x="60" y="312"/>
                  </a:lnTo>
                  <a:lnTo>
                    <a:pt x="104" y="256"/>
                  </a:lnTo>
                  <a:lnTo>
                    <a:pt x="157" y="205"/>
                  </a:lnTo>
                  <a:lnTo>
                    <a:pt x="228" y="145"/>
                  </a:lnTo>
                  <a:lnTo>
                    <a:pt x="294" y="102"/>
                  </a:lnTo>
                  <a:lnTo>
                    <a:pt x="360" y="68"/>
                  </a:lnTo>
                  <a:lnTo>
                    <a:pt x="426" y="38"/>
                  </a:lnTo>
                  <a:lnTo>
                    <a:pt x="514" y="21"/>
                  </a:lnTo>
                  <a:lnTo>
                    <a:pt x="593" y="16"/>
                  </a:lnTo>
                  <a:lnTo>
                    <a:pt x="664" y="16"/>
                  </a:lnTo>
                  <a:lnTo>
                    <a:pt x="739" y="21"/>
                  </a:lnTo>
                  <a:lnTo>
                    <a:pt x="765" y="25"/>
                  </a:lnTo>
                  <a:lnTo>
                    <a:pt x="828" y="38"/>
                  </a:lnTo>
                  <a:lnTo>
                    <a:pt x="891" y="51"/>
                  </a:lnTo>
                  <a:lnTo>
                    <a:pt x="954" y="63"/>
                  </a:lnTo>
                  <a:lnTo>
                    <a:pt x="1016" y="76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48" name="textbox 48"/>
          <p:cNvSpPr/>
          <p:nvPr/>
        </p:nvSpPr>
        <p:spPr>
          <a:xfrm rot="16200000">
            <a:off x="-909565" y="2256942"/>
            <a:ext cx="3204210" cy="16256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      50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      1500</a:t>
            </a:r>
            <a:r>
              <a:rPr sz="9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3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      3000</a:t>
            </a:r>
            <a:r>
              <a:rPr sz="9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500</a:t>
            </a:r>
            <a:endParaRPr lang="en-US" altLang="en-US" sz="900" dirty="0"/>
          </a:p>
        </p:txBody>
      </p:sp>
      <p:sp>
        <p:nvSpPr>
          <p:cNvPr id="50" name="path"/>
          <p:cNvSpPr/>
          <p:nvPr/>
        </p:nvSpPr>
        <p:spPr>
          <a:xfrm>
            <a:off x="851274" y="3729224"/>
            <a:ext cx="71236" cy="92606"/>
          </a:xfrm>
          <a:custGeom>
            <a:avLst/>
            <a:gdLst/>
            <a:ahLst/>
            <a:cxnLst/>
            <a:rect l="0" t="0" r="0" b="0"/>
            <a:pathLst>
              <a:path w="112" h="145">
                <a:moveTo>
                  <a:pt x="106" y="140"/>
                </a:moveTo>
                <a:lnTo>
                  <a:pt x="5" y="140"/>
                </a:lnTo>
                <a:moveTo>
                  <a:pt x="106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2" name="path"/>
          <p:cNvSpPr/>
          <p:nvPr/>
        </p:nvSpPr>
        <p:spPr>
          <a:xfrm>
            <a:off x="787161" y="3038230"/>
            <a:ext cx="135349" cy="349058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"/>
          <p:cNvSpPr/>
          <p:nvPr/>
        </p:nvSpPr>
        <p:spPr>
          <a:xfrm>
            <a:off x="787161" y="2603689"/>
            <a:ext cx="135349" cy="349058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"/>
          <p:cNvSpPr/>
          <p:nvPr/>
        </p:nvSpPr>
        <p:spPr>
          <a:xfrm>
            <a:off x="787161" y="1307187"/>
            <a:ext cx="135349" cy="349057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"/>
          <p:cNvSpPr/>
          <p:nvPr/>
        </p:nvSpPr>
        <p:spPr>
          <a:xfrm>
            <a:off x="787161" y="2169147"/>
            <a:ext cx="135349" cy="356182"/>
          </a:xfrm>
          <a:custGeom>
            <a:avLst/>
            <a:gdLst/>
            <a:ahLst/>
            <a:cxnLst/>
            <a:rect l="0" t="0" r="0" b="0"/>
            <a:pathLst>
              <a:path w="213" h="560">
                <a:moveTo>
                  <a:pt x="207" y="555"/>
                </a:moveTo>
                <a:lnTo>
                  <a:pt x="106" y="555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"/>
          <p:cNvSpPr/>
          <p:nvPr/>
        </p:nvSpPr>
        <p:spPr>
          <a:xfrm>
            <a:off x="787161" y="1741729"/>
            <a:ext cx="135349" cy="349057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"/>
          <p:cNvSpPr/>
          <p:nvPr/>
        </p:nvSpPr>
        <p:spPr>
          <a:xfrm>
            <a:off x="787161" y="872645"/>
            <a:ext cx="135349" cy="356182"/>
          </a:xfrm>
          <a:custGeom>
            <a:avLst/>
            <a:gdLst/>
            <a:ahLst/>
            <a:cxnLst/>
            <a:rect l="0" t="0" r="0" b="0"/>
            <a:pathLst>
              <a:path w="213" h="560">
                <a:moveTo>
                  <a:pt x="207" y="555"/>
                </a:moveTo>
                <a:lnTo>
                  <a:pt x="106" y="555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"/>
          <p:cNvSpPr/>
          <p:nvPr/>
        </p:nvSpPr>
        <p:spPr>
          <a:xfrm>
            <a:off x="787161" y="3900191"/>
            <a:ext cx="135349" cy="7123"/>
          </a:xfrm>
          <a:custGeom>
            <a:avLst/>
            <a:gdLst/>
            <a:ahLst/>
            <a:cxnLst/>
            <a:rect l="0" t="0" r="0" b="0"/>
            <a:pathLst>
              <a:path w="213" h="11"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path"/>
          <p:cNvSpPr/>
          <p:nvPr/>
        </p:nvSpPr>
        <p:spPr>
          <a:xfrm>
            <a:off x="787161" y="3465649"/>
            <a:ext cx="135349" cy="185214"/>
          </a:xfrm>
          <a:custGeom>
            <a:avLst/>
            <a:gdLst/>
            <a:ahLst/>
            <a:cxnLst/>
            <a:rect l="0" t="0" r="0" b="0"/>
            <a:pathLst>
              <a:path w="213" h="291"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8" name="path"/>
          <p:cNvSpPr/>
          <p:nvPr/>
        </p:nvSpPr>
        <p:spPr>
          <a:xfrm>
            <a:off x="851274" y="787162"/>
            <a:ext cx="71236" cy="3120152"/>
          </a:xfrm>
          <a:custGeom>
            <a:avLst/>
            <a:gdLst/>
            <a:ahLst/>
            <a:cxnLst/>
            <a:rect l="0" t="0" r="0" b="0"/>
            <a:pathLst>
              <a:path w="112" h="4913">
                <a:moveTo>
                  <a:pt x="106" y="5"/>
                </a:moveTo>
                <a:lnTo>
                  <a:pt x="5" y="5"/>
                </a:lnTo>
                <a:moveTo>
                  <a:pt x="106" y="4908"/>
                </a:moveTo>
                <a:lnTo>
                  <a:pt x="10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path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0" name="path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"/>
          <p:cNvSpPr/>
          <p:nvPr/>
        </p:nvSpPr>
        <p:spPr>
          <a:xfrm>
            <a:off x="3472077" y="8292655"/>
            <a:ext cx="505323" cy="323383"/>
          </a:xfrm>
          <a:custGeom>
            <a:avLst/>
            <a:gdLst/>
            <a:ahLst/>
            <a:cxnLst/>
            <a:rect l="0" t="0" r="0" b="0"/>
            <a:pathLst>
              <a:path w="795" h="509">
                <a:moveTo>
                  <a:pt x="778" y="436"/>
                </a:moveTo>
                <a:lnTo>
                  <a:pt x="699" y="466"/>
                </a:lnTo>
                <a:lnTo>
                  <a:pt x="615" y="479"/>
                </a:lnTo>
                <a:moveTo>
                  <a:pt x="474" y="488"/>
                </a:moveTo>
                <a:lnTo>
                  <a:pt x="400" y="492"/>
                </a:lnTo>
                <a:lnTo>
                  <a:pt x="325" y="492"/>
                </a:lnTo>
                <a:moveTo>
                  <a:pt x="254" y="492"/>
                </a:moveTo>
                <a:lnTo>
                  <a:pt x="175" y="466"/>
                </a:lnTo>
                <a:moveTo>
                  <a:pt x="47" y="385"/>
                </a:moveTo>
                <a:lnTo>
                  <a:pt x="21" y="303"/>
                </a:lnTo>
                <a:lnTo>
                  <a:pt x="16" y="231"/>
                </a:lnTo>
                <a:moveTo>
                  <a:pt x="38" y="89"/>
                </a:moveTo>
                <a:lnTo>
                  <a:pt x="82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"/>
          <p:cNvSpPr/>
          <p:nvPr/>
        </p:nvSpPr>
        <p:spPr>
          <a:xfrm>
            <a:off x="3491659" y="8406930"/>
            <a:ext cx="659180" cy="209108"/>
          </a:xfrm>
          <a:custGeom>
            <a:avLst/>
            <a:gdLst/>
            <a:ahLst/>
            <a:cxnLst/>
            <a:rect l="0" t="0" r="0" b="0"/>
            <a:pathLst>
              <a:path w="1038" h="329">
                <a:moveTo>
                  <a:pt x="1021" y="16"/>
                </a:moveTo>
                <a:lnTo>
                  <a:pt x="981" y="81"/>
                </a:lnTo>
                <a:lnTo>
                  <a:pt x="928" y="132"/>
                </a:lnTo>
                <a:lnTo>
                  <a:pt x="875" y="179"/>
                </a:lnTo>
                <a:lnTo>
                  <a:pt x="809" y="222"/>
                </a:lnTo>
                <a:lnTo>
                  <a:pt x="748" y="256"/>
                </a:lnTo>
                <a:moveTo>
                  <a:pt x="585" y="299"/>
                </a:moveTo>
                <a:lnTo>
                  <a:pt x="514" y="308"/>
                </a:lnTo>
                <a:lnTo>
                  <a:pt x="444" y="308"/>
                </a:lnTo>
                <a:moveTo>
                  <a:pt x="294" y="312"/>
                </a:moveTo>
                <a:lnTo>
                  <a:pt x="223" y="312"/>
                </a:lnTo>
                <a:moveTo>
                  <a:pt x="144" y="286"/>
                </a:moveTo>
                <a:lnTo>
                  <a:pt x="74" y="256"/>
                </a:lnTo>
                <a:lnTo>
                  <a:pt x="16" y="20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textbox 88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lang="en-US" altLang="en-US" sz="800" dirty="0"/>
          </a:p>
        </p:txBody>
      </p:sp>
      <p:sp>
        <p:nvSpPr>
          <p:cNvPr id="90" name="textbox 90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92" name="textbox 92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94" name="textbox 94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96" name="path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path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path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path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path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0" name="path"/>
          <p:cNvSpPr/>
          <p:nvPr/>
        </p:nvSpPr>
        <p:spPr>
          <a:xfrm>
            <a:off x="55956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2" name="path"/>
          <p:cNvSpPr/>
          <p:nvPr/>
        </p:nvSpPr>
        <p:spPr>
          <a:xfrm>
            <a:off x="57879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4" name="path"/>
          <p:cNvSpPr/>
          <p:nvPr/>
        </p:nvSpPr>
        <p:spPr>
          <a:xfrm>
            <a:off x="5987417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path"/>
          <p:cNvSpPr/>
          <p:nvPr/>
        </p:nvSpPr>
        <p:spPr>
          <a:xfrm>
            <a:off x="63792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path"/>
          <p:cNvSpPr/>
          <p:nvPr/>
        </p:nvSpPr>
        <p:spPr>
          <a:xfrm>
            <a:off x="6179754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0" name="path"/>
          <p:cNvSpPr/>
          <p:nvPr/>
        </p:nvSpPr>
        <p:spPr>
          <a:xfrm>
            <a:off x="65715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2" name="path"/>
          <p:cNvSpPr/>
          <p:nvPr/>
        </p:nvSpPr>
        <p:spPr>
          <a:xfrm>
            <a:off x="5545751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4" name="path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6" name="path"/>
          <p:cNvSpPr/>
          <p:nvPr/>
        </p:nvSpPr>
        <p:spPr>
          <a:xfrm>
            <a:off x="3095220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8" name="path"/>
          <p:cNvSpPr/>
          <p:nvPr/>
        </p:nvSpPr>
        <p:spPr>
          <a:xfrm>
            <a:off x="3095220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0" name="path"/>
          <p:cNvSpPr/>
          <p:nvPr/>
        </p:nvSpPr>
        <p:spPr>
          <a:xfrm>
            <a:off x="3095220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2" name="path"/>
          <p:cNvSpPr/>
          <p:nvPr/>
        </p:nvSpPr>
        <p:spPr>
          <a:xfrm>
            <a:off x="3152209" y="8331093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4" name="path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6" name="path"/>
          <p:cNvSpPr/>
          <p:nvPr/>
        </p:nvSpPr>
        <p:spPr>
          <a:xfrm>
            <a:off x="3152209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8" name="path"/>
          <p:cNvSpPr/>
          <p:nvPr/>
        </p:nvSpPr>
        <p:spPr>
          <a:xfrm>
            <a:off x="758667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0" name="path"/>
          <p:cNvSpPr/>
          <p:nvPr/>
        </p:nvSpPr>
        <p:spPr>
          <a:xfrm>
            <a:off x="758667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2" name="path"/>
          <p:cNvSpPr/>
          <p:nvPr/>
        </p:nvSpPr>
        <p:spPr>
          <a:xfrm>
            <a:off x="758667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4" name="path"/>
          <p:cNvSpPr/>
          <p:nvPr/>
        </p:nvSpPr>
        <p:spPr>
          <a:xfrm>
            <a:off x="758667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6" name="path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8" name="path"/>
          <p:cNvSpPr/>
          <p:nvPr/>
        </p:nvSpPr>
        <p:spPr>
          <a:xfrm>
            <a:off x="815656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0" name="textbox 150"/>
          <p:cNvSpPr/>
          <p:nvPr/>
        </p:nvSpPr>
        <p:spPr>
          <a:xfrm>
            <a:off x="3991524" y="454610"/>
            <a:ext cx="309245" cy="28638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122000"/>
              </a:lnSpc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700" dirty="0"/>
          </a:p>
        </p:txBody>
      </p:sp>
      <p:sp>
        <p:nvSpPr>
          <p:cNvPr id="152" name="path"/>
          <p:cNvSpPr/>
          <p:nvPr/>
        </p:nvSpPr>
        <p:spPr>
          <a:xfrm>
            <a:off x="6203142" y="8289934"/>
            <a:ext cx="270340" cy="247200"/>
          </a:xfrm>
          <a:custGeom>
            <a:avLst/>
            <a:gdLst/>
            <a:ahLst/>
            <a:cxnLst/>
            <a:rect l="0" t="0" r="0" b="0"/>
            <a:pathLst>
              <a:path w="425" h="389">
                <a:moveTo>
                  <a:pt x="408" y="16"/>
                </a:moveTo>
                <a:lnTo>
                  <a:pt x="364" y="76"/>
                </a:lnTo>
                <a:lnTo>
                  <a:pt x="311" y="128"/>
                </a:lnTo>
                <a:lnTo>
                  <a:pt x="254" y="188"/>
                </a:lnTo>
                <a:lnTo>
                  <a:pt x="193" y="243"/>
                </a:lnTo>
                <a:lnTo>
                  <a:pt x="135" y="291"/>
                </a:lnTo>
                <a:lnTo>
                  <a:pt x="78" y="333"/>
                </a:lnTo>
                <a:lnTo>
                  <a:pt x="16" y="372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4" name="textbox 154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lang="en-US" altLang="en-US" sz="900" dirty="0"/>
          </a:p>
        </p:txBody>
      </p:sp>
      <p:sp>
        <p:nvSpPr>
          <p:cNvPr id="156" name="path"/>
          <p:cNvSpPr/>
          <p:nvPr/>
        </p:nvSpPr>
        <p:spPr>
          <a:xfrm>
            <a:off x="5431773" y="7447762"/>
            <a:ext cx="121101" cy="470159"/>
          </a:xfrm>
          <a:custGeom>
            <a:avLst/>
            <a:gdLst/>
            <a:ahLst/>
            <a:cxnLst/>
            <a:rect l="0" t="0" r="0" b="0"/>
            <a:pathLst>
              <a:path w="190" h="740"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8" name="textbox 158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lang="en-US" altLang="en-US" sz="800" dirty="0"/>
          </a:p>
        </p:txBody>
      </p:sp>
      <p:pic>
        <p:nvPicPr>
          <p:cNvPr id="160" name="picture 16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162" name="textbox 162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lang="en-US" altLang="en-US" sz="1000" dirty="0"/>
          </a:p>
        </p:txBody>
      </p:sp>
      <p:sp>
        <p:nvSpPr>
          <p:cNvPr id="164" name="textbox 164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lang="en-US" altLang="en-US" sz="1000" dirty="0"/>
          </a:p>
        </p:txBody>
      </p:sp>
      <p:pic>
        <p:nvPicPr>
          <p:cNvPr id="166" name="picture 16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220832"/>
          </a:xfrm>
          <a:prstGeom prst="rect">
            <a:avLst/>
          </a:prstGeom>
        </p:spPr>
      </p:pic>
      <p:sp>
        <p:nvSpPr>
          <p:cNvPr id="168" name="textbox 168"/>
          <p:cNvSpPr/>
          <p:nvPr/>
        </p:nvSpPr>
        <p:spPr>
          <a:xfrm rot="16200000">
            <a:off x="5062046" y="7924598"/>
            <a:ext cx="259715" cy="16891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2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4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lang="en-US" altLang="en-US" sz="900" dirty="0"/>
          </a:p>
        </p:txBody>
      </p:sp>
      <p:sp>
        <p:nvSpPr>
          <p:cNvPr id="170" name="path"/>
          <p:cNvSpPr/>
          <p:nvPr/>
        </p:nvSpPr>
        <p:spPr>
          <a:xfrm>
            <a:off x="6421340" y="8036897"/>
            <a:ext cx="74521" cy="274408"/>
          </a:xfrm>
          <a:custGeom>
            <a:avLst/>
            <a:gdLst/>
            <a:ahLst/>
            <a:cxnLst/>
            <a:rect l="0" t="0" r="0" b="0"/>
            <a:pathLst>
              <a:path w="117" h="432">
                <a:moveTo>
                  <a:pt x="16" y="16"/>
                </a:moveTo>
                <a:lnTo>
                  <a:pt x="60" y="98"/>
                </a:lnTo>
                <a:lnTo>
                  <a:pt x="91" y="183"/>
                </a:lnTo>
                <a:lnTo>
                  <a:pt x="100" y="256"/>
                </a:lnTo>
                <a:moveTo>
                  <a:pt x="100" y="333"/>
                </a:moveTo>
                <a:lnTo>
                  <a:pt x="65" y="41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2" name="rect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4" name="rect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6" name="rect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8" name="path"/>
          <p:cNvSpPr/>
          <p:nvPr/>
        </p:nvSpPr>
        <p:spPr>
          <a:xfrm>
            <a:off x="5431773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0" name="path"/>
          <p:cNvSpPr/>
          <p:nvPr/>
        </p:nvSpPr>
        <p:spPr>
          <a:xfrm>
            <a:off x="5431773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2" name="path"/>
          <p:cNvSpPr/>
          <p:nvPr/>
        </p:nvSpPr>
        <p:spPr>
          <a:xfrm>
            <a:off x="5431773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4" name="textbox 184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lang="en-US" altLang="en-US" sz="1000" dirty="0"/>
          </a:p>
        </p:txBody>
      </p:sp>
      <p:sp>
        <p:nvSpPr>
          <p:cNvPr id="186" name="textbox 186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lang="en-US" altLang="en-US" sz="1000" dirty="0"/>
          </a:p>
        </p:txBody>
      </p:sp>
      <p:sp>
        <p:nvSpPr>
          <p:cNvPr id="188" name="textbox 188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1000" dirty="0"/>
          </a:p>
        </p:txBody>
      </p:sp>
      <p:sp>
        <p:nvSpPr>
          <p:cNvPr id="190" name="path"/>
          <p:cNvSpPr/>
          <p:nvPr/>
        </p:nvSpPr>
        <p:spPr>
          <a:xfrm>
            <a:off x="6010120" y="8515763"/>
            <a:ext cx="214392" cy="45858"/>
          </a:xfrm>
          <a:custGeom>
            <a:avLst/>
            <a:gdLst/>
            <a:ahLst/>
            <a:cxnLst/>
            <a:rect l="0" t="0" r="0" b="0"/>
            <a:pathLst>
              <a:path w="337" h="72">
                <a:moveTo>
                  <a:pt x="320" y="16"/>
                </a:moveTo>
                <a:lnTo>
                  <a:pt x="245" y="38"/>
                </a:lnTo>
                <a:lnTo>
                  <a:pt x="171" y="51"/>
                </a:lnTo>
                <a:lnTo>
                  <a:pt x="91" y="55"/>
                </a:lnTo>
                <a:lnTo>
                  <a:pt x="16" y="5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2" name="path"/>
          <p:cNvSpPr/>
          <p:nvPr/>
        </p:nvSpPr>
        <p:spPr>
          <a:xfrm>
            <a:off x="5488762" y="7960664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4" name="path"/>
          <p:cNvSpPr/>
          <p:nvPr/>
        </p:nvSpPr>
        <p:spPr>
          <a:xfrm>
            <a:off x="5431773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6" name="path"/>
          <p:cNvSpPr/>
          <p:nvPr/>
        </p:nvSpPr>
        <p:spPr>
          <a:xfrm>
            <a:off x="5545751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8" name="path"/>
          <p:cNvSpPr/>
          <p:nvPr/>
        </p:nvSpPr>
        <p:spPr>
          <a:xfrm>
            <a:off x="4129468" y="8298096"/>
            <a:ext cx="60534" cy="130204"/>
          </a:xfrm>
          <a:custGeom>
            <a:avLst/>
            <a:gdLst/>
            <a:ahLst/>
            <a:cxnLst/>
            <a:rect l="0" t="0" r="0" b="0"/>
            <a:pathLst>
              <a:path w="95" h="205">
                <a:moveTo>
                  <a:pt x="78" y="16"/>
                </a:moveTo>
                <a:lnTo>
                  <a:pt x="52" y="111"/>
                </a:lnTo>
                <a:lnTo>
                  <a:pt x="16" y="188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0" name="path"/>
          <p:cNvSpPr/>
          <p:nvPr/>
        </p:nvSpPr>
        <p:spPr>
          <a:xfrm>
            <a:off x="3472077" y="8338908"/>
            <a:ext cx="35358" cy="111158"/>
          </a:xfrm>
          <a:custGeom>
            <a:avLst/>
            <a:gdLst/>
            <a:ahLst/>
            <a:cxnLst/>
            <a:rect l="0" t="0" r="0" b="0"/>
            <a:pathLst>
              <a:path w="55" h="175">
                <a:moveTo>
                  <a:pt x="16" y="158"/>
                </a:moveTo>
                <a:lnTo>
                  <a:pt x="16" y="121"/>
                </a:lnTo>
                <a:lnTo>
                  <a:pt x="16" y="85"/>
                </a:lnTo>
                <a:lnTo>
                  <a:pt x="38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2" name="path"/>
          <p:cNvSpPr/>
          <p:nvPr/>
        </p:nvSpPr>
        <p:spPr>
          <a:xfrm>
            <a:off x="6474490" y="8189262"/>
            <a:ext cx="21371" cy="70345"/>
          </a:xfrm>
          <a:custGeom>
            <a:avLst/>
            <a:gdLst/>
            <a:ahLst/>
            <a:cxnLst/>
            <a:rect l="0" t="0" r="0" b="0"/>
            <a:pathLst>
              <a:path w="33" h="110">
                <a:moveTo>
                  <a:pt x="16" y="16"/>
                </a:moveTo>
                <a:lnTo>
                  <a:pt x="16" y="55"/>
                </a:lnTo>
                <a:lnTo>
                  <a:pt x="16" y="93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aphicFrame>
        <p:nvGraphicFramePr>
          <p:cNvPr id="7" name="表格 6"/>
          <p:cNvGraphicFramePr/>
          <p:nvPr/>
        </p:nvGraphicFramePr>
        <p:xfrm>
          <a:off x="3435350" y="5226050"/>
          <a:ext cx="685800" cy="190500"/>
        </p:xfrm>
        <a:graphic>
          <a:graphicData uri="http://schemas.openxmlformats.org/drawingml/2006/table">
            <a:tbl>
              <a:tblPr/>
              <a:tblGrid>
                <a:gridCol w="685800"/>
              </a:tblGrid>
              <a:tr h="1905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zh-CN" sz="12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用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9" name="表格 8"/>
          <p:cNvGraphicFramePr/>
          <p:nvPr/>
        </p:nvGraphicFramePr>
        <p:xfrm>
          <a:off x="3435350" y="5226050"/>
          <a:ext cx="685800" cy="190500"/>
        </p:xfrm>
        <a:graphic>
          <a:graphicData uri="http://schemas.openxmlformats.org/drawingml/2006/table">
            <a:tbl>
              <a:tblPr/>
              <a:tblGrid>
                <a:gridCol w="685800"/>
              </a:tblGrid>
              <a:tr h="1905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zh-CN" sz="12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用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1" name="表格 10"/>
          <p:cNvGraphicFramePr/>
          <p:nvPr/>
        </p:nvGraphicFramePr>
        <p:xfrm>
          <a:off x="3435350" y="5226050"/>
          <a:ext cx="685800" cy="190500"/>
        </p:xfrm>
        <a:graphic>
          <a:graphicData uri="http://schemas.openxmlformats.org/drawingml/2006/table">
            <a:tbl>
              <a:tblPr/>
              <a:tblGrid>
                <a:gridCol w="685800"/>
              </a:tblGrid>
              <a:tr h="1905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zh-CN" sz="12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用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3" name="表格 12"/>
          <p:cNvGraphicFramePr/>
          <p:nvPr/>
        </p:nvGraphicFramePr>
        <p:xfrm>
          <a:off x="3435350" y="5226050"/>
          <a:ext cx="685800" cy="190500"/>
        </p:xfrm>
        <a:graphic>
          <a:graphicData uri="http://schemas.openxmlformats.org/drawingml/2006/table">
            <a:tbl>
              <a:tblPr/>
              <a:tblGrid>
                <a:gridCol w="685800"/>
              </a:tblGrid>
              <a:tr h="19050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zh-CN" sz="12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用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787161" y="3643903"/>
            <a:ext cx="3758357" cy="391636"/>
          </a:xfrm>
          <a:prstGeom prst="rect">
            <a:avLst/>
          </a:prstGeom>
        </p:spPr>
      </p:pic>
      <p:sp>
        <p:nvSpPr>
          <p:cNvPr id="4" name="path 4"/>
          <p:cNvSpPr/>
          <p:nvPr/>
        </p:nvSpPr>
        <p:spPr>
          <a:xfrm>
            <a:off x="2062255" y="929342"/>
            <a:ext cx="334312" cy="2767305"/>
          </a:xfrm>
          <a:custGeom>
            <a:avLst/>
            <a:gdLst/>
            <a:ahLst/>
            <a:cxnLst/>
            <a:rect l="0" t="0" r="0" b="0"/>
            <a:pathLst>
              <a:path w="526" h="4357">
                <a:moveTo>
                  <a:pt x="7" y="4349"/>
                </a:moveTo>
                <a:lnTo>
                  <a:pt x="35" y="4164"/>
                </a:lnTo>
                <a:lnTo>
                  <a:pt x="64" y="3988"/>
                </a:lnTo>
                <a:lnTo>
                  <a:pt x="92" y="3711"/>
                </a:lnTo>
                <a:lnTo>
                  <a:pt x="121" y="3550"/>
                </a:lnTo>
                <a:lnTo>
                  <a:pt x="149" y="3238"/>
                </a:lnTo>
                <a:lnTo>
                  <a:pt x="177" y="2986"/>
                </a:lnTo>
                <a:lnTo>
                  <a:pt x="206" y="2632"/>
                </a:lnTo>
                <a:lnTo>
                  <a:pt x="234" y="2107"/>
                </a:lnTo>
                <a:lnTo>
                  <a:pt x="263" y="1324"/>
                </a:lnTo>
                <a:lnTo>
                  <a:pt x="291" y="623"/>
                </a:lnTo>
                <a:lnTo>
                  <a:pt x="320" y="7"/>
                </a:lnTo>
                <a:lnTo>
                  <a:pt x="348" y="520"/>
                </a:lnTo>
                <a:lnTo>
                  <a:pt x="376" y="1562"/>
                </a:lnTo>
                <a:lnTo>
                  <a:pt x="405" y="2493"/>
                </a:lnTo>
                <a:lnTo>
                  <a:pt x="433" y="3321"/>
                </a:lnTo>
                <a:lnTo>
                  <a:pt x="462" y="3913"/>
                </a:lnTo>
                <a:lnTo>
                  <a:pt x="490" y="4181"/>
                </a:lnTo>
                <a:lnTo>
                  <a:pt x="519" y="4350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6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477026"/>
            <a:ext cx="3611684" cy="2424121"/>
          </a:xfrm>
          <a:prstGeom prst="rect">
            <a:avLst/>
          </a:prstGeom>
        </p:spPr>
      </p:pic>
      <p:sp>
        <p:nvSpPr>
          <p:cNvPr id="8" name="textbox 8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 analyzed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_11_011.fcs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3.51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9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21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2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8.2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90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8.2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053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05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9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.444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0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12" name="path 12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4" name="path 14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6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18" name="path 18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6" name="textbox 26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8" name="textbox 2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0" name="textbox 3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path 34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6" name="path 36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8" name="textbox 38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textbox 40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42" name="picture 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44" name="picture 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46" name="textbox 46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8" name="textbox 48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0" name="textbox 50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2" name="path 52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 54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 56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 58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 60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textbox 66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8" name="path 68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textbox 78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80" name="picture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2" name="textbox 82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4" name="textbox 84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6" name="textbox 86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8" name="path 88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rect 92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rect 94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rect 96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textbox 9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textbox 10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2" name="textbox 10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4" name="path 104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 106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 108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 2"/>
          <p:cNvSpPr/>
          <p:nvPr/>
        </p:nvSpPr>
        <p:spPr>
          <a:xfrm>
            <a:off x="3488869" y="3610084"/>
            <a:ext cx="135669" cy="136947"/>
          </a:xfrm>
          <a:custGeom>
            <a:avLst/>
            <a:gdLst/>
            <a:ahLst/>
            <a:cxnLst/>
            <a:rect l="0" t="0" r="0" b="0"/>
            <a:pathLst>
              <a:path w="213" h="215">
                <a:moveTo>
                  <a:pt x="7" y="129"/>
                </a:moveTo>
                <a:lnTo>
                  <a:pt x="35" y="130"/>
                </a:lnTo>
                <a:lnTo>
                  <a:pt x="64" y="94"/>
                </a:lnTo>
                <a:lnTo>
                  <a:pt x="92" y="23"/>
                </a:lnTo>
                <a:lnTo>
                  <a:pt x="121" y="49"/>
                </a:lnTo>
                <a:lnTo>
                  <a:pt x="149" y="7"/>
                </a:lnTo>
                <a:lnTo>
                  <a:pt x="177" y="88"/>
                </a:lnTo>
                <a:lnTo>
                  <a:pt x="206" y="208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4" name="picture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787161" y="3687732"/>
            <a:ext cx="3758357" cy="347808"/>
          </a:xfrm>
          <a:prstGeom prst="rect">
            <a:avLst/>
          </a:prstGeom>
        </p:spPr>
      </p:pic>
      <p:sp>
        <p:nvSpPr>
          <p:cNvPr id="6" name="path 6"/>
          <p:cNvSpPr/>
          <p:nvPr/>
        </p:nvSpPr>
        <p:spPr>
          <a:xfrm>
            <a:off x="2080313" y="1124497"/>
            <a:ext cx="280136" cy="2620809"/>
          </a:xfrm>
          <a:custGeom>
            <a:avLst/>
            <a:gdLst/>
            <a:ahLst/>
            <a:cxnLst/>
            <a:rect l="0" t="0" r="0" b="0"/>
            <a:pathLst>
              <a:path w="441" h="4127">
                <a:moveTo>
                  <a:pt x="7" y="4102"/>
                </a:moveTo>
                <a:lnTo>
                  <a:pt x="35" y="3962"/>
                </a:lnTo>
                <a:lnTo>
                  <a:pt x="64" y="3770"/>
                </a:lnTo>
                <a:lnTo>
                  <a:pt x="92" y="3607"/>
                </a:lnTo>
                <a:lnTo>
                  <a:pt x="121" y="3337"/>
                </a:lnTo>
                <a:lnTo>
                  <a:pt x="149" y="2996"/>
                </a:lnTo>
                <a:lnTo>
                  <a:pt x="177" y="2725"/>
                </a:lnTo>
                <a:lnTo>
                  <a:pt x="206" y="2115"/>
                </a:lnTo>
                <a:lnTo>
                  <a:pt x="234" y="1330"/>
                </a:lnTo>
                <a:lnTo>
                  <a:pt x="263" y="304"/>
                </a:lnTo>
                <a:lnTo>
                  <a:pt x="291" y="7"/>
                </a:lnTo>
                <a:lnTo>
                  <a:pt x="320" y="602"/>
                </a:lnTo>
                <a:lnTo>
                  <a:pt x="348" y="2106"/>
                </a:lnTo>
                <a:lnTo>
                  <a:pt x="376" y="3228"/>
                </a:lnTo>
                <a:lnTo>
                  <a:pt x="405" y="3893"/>
                </a:lnTo>
                <a:lnTo>
                  <a:pt x="433" y="4119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8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464401"/>
            <a:ext cx="3611684" cy="2436747"/>
          </a:xfrm>
          <a:prstGeom prst="rect">
            <a:avLst/>
          </a:prstGeom>
        </p:spPr>
      </p:pic>
      <p:sp>
        <p:nvSpPr>
          <p:cNvPr id="10" name="textbox 10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40105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</a:t>
            </a:r>
            <a:r>
              <a:rPr sz="1000" u="sng" kern="0" spc="-4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4.f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s</a:t>
            </a:r>
            <a:r>
              <a:rPr sz="10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-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Jan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-2024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6.81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88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.6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5.04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.55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9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.66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.55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866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866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81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2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.577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2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758667" y="7426391"/>
            <a:ext cx="1353491" cy="1303625"/>
            <a:chOff x="0" y="0"/>
            <a:chExt cx="1353491" cy="1303625"/>
          </a:xfrm>
        </p:grpSpPr>
        <p:sp>
          <p:nvSpPr>
            <p:cNvPr id="14" name="path 14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6" name="path 16"/>
            <p:cNvSpPr/>
            <p:nvPr/>
          </p:nvSpPr>
          <p:spPr>
            <a:xfrm>
              <a:off x="251051" y="613225"/>
              <a:ext cx="852201" cy="394125"/>
            </a:xfrm>
            <a:custGeom>
              <a:avLst/>
              <a:gdLst/>
              <a:ahLst/>
              <a:cxnLst/>
              <a:rect l="0" t="0" r="0" b="0"/>
              <a:pathLst>
                <a:path w="1342" h="620">
                  <a:moveTo>
                    <a:pt x="563" y="16"/>
                  </a:moveTo>
                  <a:lnTo>
                    <a:pt x="633" y="16"/>
                  </a:lnTo>
                  <a:lnTo>
                    <a:pt x="717" y="16"/>
                  </a:lnTo>
                  <a:lnTo>
                    <a:pt x="774" y="18"/>
                  </a:lnTo>
                  <a:lnTo>
                    <a:pt x="831" y="21"/>
                  </a:lnTo>
                  <a:lnTo>
                    <a:pt x="889" y="29"/>
                  </a:lnTo>
                  <a:lnTo>
                    <a:pt x="946" y="38"/>
                  </a:lnTo>
                  <a:lnTo>
                    <a:pt x="1038" y="51"/>
                  </a:lnTo>
                  <a:lnTo>
                    <a:pt x="1131" y="68"/>
                  </a:lnTo>
                  <a:lnTo>
                    <a:pt x="1206" y="93"/>
                  </a:lnTo>
                  <a:lnTo>
                    <a:pt x="1276" y="132"/>
                  </a:lnTo>
                  <a:lnTo>
                    <a:pt x="1316" y="192"/>
                  </a:lnTo>
                  <a:lnTo>
                    <a:pt x="1325" y="261"/>
                  </a:lnTo>
                  <a:lnTo>
                    <a:pt x="1289" y="333"/>
                  </a:lnTo>
                  <a:lnTo>
                    <a:pt x="1232" y="381"/>
                  </a:lnTo>
                  <a:lnTo>
                    <a:pt x="1171" y="419"/>
                  </a:lnTo>
                  <a:lnTo>
                    <a:pt x="1109" y="453"/>
                  </a:lnTo>
                  <a:lnTo>
                    <a:pt x="1043" y="479"/>
                  </a:lnTo>
                  <a:lnTo>
                    <a:pt x="992" y="494"/>
                  </a:lnTo>
                  <a:lnTo>
                    <a:pt x="941" y="509"/>
                  </a:lnTo>
                  <a:lnTo>
                    <a:pt x="871" y="526"/>
                  </a:lnTo>
                  <a:lnTo>
                    <a:pt x="800" y="543"/>
                  </a:lnTo>
                  <a:lnTo>
                    <a:pt x="730" y="552"/>
                  </a:lnTo>
                  <a:lnTo>
                    <a:pt x="660" y="565"/>
                  </a:lnTo>
                  <a:lnTo>
                    <a:pt x="567" y="586"/>
                  </a:lnTo>
                  <a:lnTo>
                    <a:pt x="483" y="599"/>
                  </a:lnTo>
                  <a:lnTo>
                    <a:pt x="395" y="603"/>
                  </a:lnTo>
                  <a:lnTo>
                    <a:pt x="320" y="603"/>
                  </a:lnTo>
                  <a:lnTo>
                    <a:pt x="232" y="573"/>
                  </a:lnTo>
                  <a:lnTo>
                    <a:pt x="166" y="543"/>
                  </a:lnTo>
                  <a:lnTo>
                    <a:pt x="100" y="518"/>
                  </a:lnTo>
                  <a:lnTo>
                    <a:pt x="38" y="471"/>
                  </a:lnTo>
                  <a:lnTo>
                    <a:pt x="21" y="398"/>
                  </a:lnTo>
                  <a:lnTo>
                    <a:pt x="16" y="325"/>
                  </a:lnTo>
                  <a:lnTo>
                    <a:pt x="56" y="248"/>
                  </a:lnTo>
                  <a:lnTo>
                    <a:pt x="104" y="183"/>
                  </a:lnTo>
                  <a:lnTo>
                    <a:pt x="153" y="123"/>
                  </a:lnTo>
                  <a:lnTo>
                    <a:pt x="201" y="93"/>
                  </a:lnTo>
                  <a:lnTo>
                    <a:pt x="274" y="78"/>
                  </a:lnTo>
                  <a:lnTo>
                    <a:pt x="346" y="63"/>
                  </a:lnTo>
                  <a:lnTo>
                    <a:pt x="418" y="47"/>
                  </a:lnTo>
                  <a:lnTo>
                    <a:pt x="490" y="32"/>
                  </a:lnTo>
                  <a:lnTo>
                    <a:pt x="563" y="1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8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20" name="path 20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2" name="path 22"/>
            <p:cNvSpPr/>
            <p:nvPr/>
          </p:nvSpPr>
          <p:spPr>
            <a:xfrm>
              <a:off x="298606" y="520717"/>
              <a:ext cx="745900" cy="636279"/>
            </a:xfrm>
            <a:custGeom>
              <a:avLst/>
              <a:gdLst/>
              <a:ahLst/>
              <a:cxnLst/>
              <a:rect l="0" t="0" r="0" b="0"/>
              <a:pathLst>
                <a:path w="1174" h="1002">
                  <a:moveTo>
                    <a:pt x="1007" y="51"/>
                  </a:moveTo>
                  <a:lnTo>
                    <a:pt x="1052" y="112"/>
                  </a:lnTo>
                  <a:lnTo>
                    <a:pt x="1093" y="182"/>
                  </a:lnTo>
                  <a:lnTo>
                    <a:pt x="1121" y="265"/>
                  </a:lnTo>
                  <a:lnTo>
                    <a:pt x="1139" y="339"/>
                  </a:lnTo>
                  <a:lnTo>
                    <a:pt x="1157" y="409"/>
                  </a:lnTo>
                  <a:lnTo>
                    <a:pt x="1157" y="448"/>
                  </a:lnTo>
                  <a:lnTo>
                    <a:pt x="1157" y="487"/>
                  </a:lnTo>
                  <a:lnTo>
                    <a:pt x="1144" y="570"/>
                  </a:lnTo>
                  <a:lnTo>
                    <a:pt x="1103" y="644"/>
                  </a:lnTo>
                  <a:lnTo>
                    <a:pt x="1048" y="723"/>
                  </a:lnTo>
                  <a:lnTo>
                    <a:pt x="979" y="788"/>
                  </a:lnTo>
                  <a:lnTo>
                    <a:pt x="915" y="836"/>
                  </a:lnTo>
                  <a:lnTo>
                    <a:pt x="842" y="880"/>
                  </a:lnTo>
                  <a:lnTo>
                    <a:pt x="779" y="915"/>
                  </a:lnTo>
                  <a:lnTo>
                    <a:pt x="692" y="941"/>
                  </a:lnTo>
                  <a:lnTo>
                    <a:pt x="605" y="963"/>
                  </a:lnTo>
                  <a:lnTo>
                    <a:pt x="518" y="980"/>
                  </a:lnTo>
                  <a:lnTo>
                    <a:pt x="436" y="985"/>
                  </a:lnTo>
                  <a:lnTo>
                    <a:pt x="359" y="985"/>
                  </a:lnTo>
                  <a:lnTo>
                    <a:pt x="286" y="972"/>
                  </a:lnTo>
                  <a:lnTo>
                    <a:pt x="208" y="954"/>
                  </a:lnTo>
                  <a:lnTo>
                    <a:pt x="130" y="915"/>
                  </a:lnTo>
                  <a:lnTo>
                    <a:pt x="80" y="858"/>
                  </a:lnTo>
                  <a:lnTo>
                    <a:pt x="44" y="788"/>
                  </a:lnTo>
                  <a:lnTo>
                    <a:pt x="21" y="714"/>
                  </a:lnTo>
                  <a:lnTo>
                    <a:pt x="16" y="636"/>
                  </a:lnTo>
                  <a:lnTo>
                    <a:pt x="16" y="596"/>
                  </a:lnTo>
                  <a:lnTo>
                    <a:pt x="16" y="557"/>
                  </a:lnTo>
                  <a:lnTo>
                    <a:pt x="53" y="496"/>
                  </a:lnTo>
                  <a:lnTo>
                    <a:pt x="98" y="422"/>
                  </a:lnTo>
                  <a:lnTo>
                    <a:pt x="158" y="352"/>
                  </a:lnTo>
                  <a:lnTo>
                    <a:pt x="222" y="291"/>
                  </a:lnTo>
                  <a:lnTo>
                    <a:pt x="272" y="239"/>
                  </a:lnTo>
                  <a:lnTo>
                    <a:pt x="336" y="186"/>
                  </a:lnTo>
                  <a:lnTo>
                    <a:pt x="404" y="138"/>
                  </a:lnTo>
                  <a:lnTo>
                    <a:pt x="477" y="90"/>
                  </a:lnTo>
                  <a:lnTo>
                    <a:pt x="541" y="56"/>
                  </a:lnTo>
                  <a:lnTo>
                    <a:pt x="614" y="29"/>
                  </a:lnTo>
                  <a:lnTo>
                    <a:pt x="687" y="16"/>
                  </a:lnTo>
                  <a:lnTo>
                    <a:pt x="701" y="16"/>
                  </a:lnTo>
                  <a:lnTo>
                    <a:pt x="777" y="25"/>
                  </a:lnTo>
                  <a:lnTo>
                    <a:pt x="854" y="34"/>
                  </a:lnTo>
                  <a:lnTo>
                    <a:pt x="930" y="42"/>
                  </a:lnTo>
                  <a:lnTo>
                    <a:pt x="1007" y="5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4" name="picture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sp>
        <p:nvSpPr>
          <p:cNvPr id="26" name="textbox 26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8" name="path 28"/>
          <p:cNvSpPr/>
          <p:nvPr/>
        </p:nvSpPr>
        <p:spPr>
          <a:xfrm>
            <a:off x="3326689" y="7895413"/>
            <a:ext cx="821430" cy="701579"/>
          </a:xfrm>
          <a:custGeom>
            <a:avLst/>
            <a:gdLst/>
            <a:ahLst/>
            <a:cxnLst/>
            <a:rect l="0" t="0" r="0" b="0"/>
            <a:pathLst>
              <a:path w="1293" h="1104">
                <a:moveTo>
                  <a:pt x="1276" y="136"/>
                </a:moveTo>
                <a:lnTo>
                  <a:pt x="1276" y="205"/>
                </a:lnTo>
                <a:lnTo>
                  <a:pt x="1263" y="273"/>
                </a:lnTo>
                <a:lnTo>
                  <a:pt x="1248" y="325"/>
                </a:lnTo>
                <a:lnTo>
                  <a:pt x="1232" y="376"/>
                </a:lnTo>
                <a:lnTo>
                  <a:pt x="1210" y="426"/>
                </a:lnTo>
                <a:lnTo>
                  <a:pt x="1188" y="475"/>
                </a:lnTo>
                <a:lnTo>
                  <a:pt x="1144" y="560"/>
                </a:lnTo>
                <a:lnTo>
                  <a:pt x="1100" y="642"/>
                </a:lnTo>
                <a:lnTo>
                  <a:pt x="1052" y="710"/>
                </a:lnTo>
                <a:lnTo>
                  <a:pt x="994" y="775"/>
                </a:lnTo>
                <a:lnTo>
                  <a:pt x="928" y="835"/>
                </a:lnTo>
                <a:lnTo>
                  <a:pt x="862" y="886"/>
                </a:lnTo>
                <a:lnTo>
                  <a:pt x="796" y="929"/>
                </a:lnTo>
                <a:lnTo>
                  <a:pt x="730" y="959"/>
                </a:lnTo>
                <a:lnTo>
                  <a:pt x="646" y="993"/>
                </a:lnTo>
                <a:lnTo>
                  <a:pt x="558" y="1028"/>
                </a:lnTo>
                <a:lnTo>
                  <a:pt x="474" y="1053"/>
                </a:lnTo>
                <a:lnTo>
                  <a:pt x="391" y="1075"/>
                </a:lnTo>
                <a:lnTo>
                  <a:pt x="303" y="1088"/>
                </a:lnTo>
                <a:lnTo>
                  <a:pt x="232" y="1088"/>
                </a:lnTo>
                <a:lnTo>
                  <a:pt x="162" y="1088"/>
                </a:lnTo>
                <a:lnTo>
                  <a:pt x="96" y="1028"/>
                </a:lnTo>
                <a:lnTo>
                  <a:pt x="60" y="963"/>
                </a:lnTo>
                <a:lnTo>
                  <a:pt x="30" y="882"/>
                </a:lnTo>
                <a:lnTo>
                  <a:pt x="16" y="800"/>
                </a:lnTo>
                <a:lnTo>
                  <a:pt x="21" y="723"/>
                </a:lnTo>
                <a:lnTo>
                  <a:pt x="38" y="650"/>
                </a:lnTo>
                <a:lnTo>
                  <a:pt x="74" y="586"/>
                </a:lnTo>
                <a:lnTo>
                  <a:pt x="118" y="505"/>
                </a:lnTo>
                <a:lnTo>
                  <a:pt x="166" y="436"/>
                </a:lnTo>
                <a:lnTo>
                  <a:pt x="228" y="372"/>
                </a:lnTo>
                <a:lnTo>
                  <a:pt x="303" y="312"/>
                </a:lnTo>
                <a:lnTo>
                  <a:pt x="369" y="265"/>
                </a:lnTo>
                <a:lnTo>
                  <a:pt x="430" y="218"/>
                </a:lnTo>
                <a:lnTo>
                  <a:pt x="510" y="171"/>
                </a:lnTo>
                <a:lnTo>
                  <a:pt x="580" y="128"/>
                </a:lnTo>
                <a:lnTo>
                  <a:pt x="673" y="85"/>
                </a:lnTo>
                <a:lnTo>
                  <a:pt x="743" y="55"/>
                </a:lnTo>
                <a:lnTo>
                  <a:pt x="823" y="33"/>
                </a:lnTo>
                <a:lnTo>
                  <a:pt x="897" y="16"/>
                </a:lnTo>
                <a:lnTo>
                  <a:pt x="972" y="16"/>
                </a:lnTo>
                <a:lnTo>
                  <a:pt x="1047" y="21"/>
                </a:lnTo>
                <a:lnTo>
                  <a:pt x="1122" y="33"/>
                </a:lnTo>
                <a:lnTo>
                  <a:pt x="1175" y="42"/>
                </a:lnTo>
                <a:lnTo>
                  <a:pt x="1226" y="89"/>
                </a:lnTo>
                <a:lnTo>
                  <a:pt x="1276" y="136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0" name="textbox 30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textbox 34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6" name="textbox 36"/>
          <p:cNvSpPr/>
          <p:nvPr/>
        </p:nvSpPr>
        <p:spPr>
          <a:xfrm rot="16200000">
            <a:off x="-909565" y="2256942"/>
            <a:ext cx="3204210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      50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      1500</a:t>
            </a:r>
            <a:r>
              <a:rPr sz="9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3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      3000</a:t>
            </a:r>
            <a:r>
              <a:rPr sz="9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5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8" name="path 38"/>
          <p:cNvSpPr/>
          <p:nvPr/>
        </p:nvSpPr>
        <p:spPr>
          <a:xfrm>
            <a:off x="787161" y="3465649"/>
            <a:ext cx="135349" cy="185214"/>
          </a:xfrm>
          <a:custGeom>
            <a:avLst/>
            <a:gdLst/>
            <a:ahLst/>
            <a:cxnLst/>
            <a:rect l="0" t="0" r="0" b="0"/>
            <a:pathLst>
              <a:path w="213" h="291"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0" name="path 40"/>
          <p:cNvSpPr/>
          <p:nvPr/>
        </p:nvSpPr>
        <p:spPr>
          <a:xfrm>
            <a:off x="787161" y="3038230"/>
            <a:ext cx="135349" cy="349058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2" name="path 42"/>
          <p:cNvSpPr/>
          <p:nvPr/>
        </p:nvSpPr>
        <p:spPr>
          <a:xfrm>
            <a:off x="787161" y="2603689"/>
            <a:ext cx="135349" cy="349058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4" name="path 44"/>
          <p:cNvSpPr/>
          <p:nvPr/>
        </p:nvSpPr>
        <p:spPr>
          <a:xfrm>
            <a:off x="787161" y="2169147"/>
            <a:ext cx="135349" cy="356182"/>
          </a:xfrm>
          <a:custGeom>
            <a:avLst/>
            <a:gdLst/>
            <a:ahLst/>
            <a:cxnLst/>
            <a:rect l="0" t="0" r="0" b="0"/>
            <a:pathLst>
              <a:path w="213" h="560">
                <a:moveTo>
                  <a:pt x="207" y="555"/>
                </a:moveTo>
                <a:lnTo>
                  <a:pt x="106" y="555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86"/>
                </a:moveTo>
                <a:lnTo>
                  <a:pt x="106" y="286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6" name="path 46"/>
          <p:cNvSpPr/>
          <p:nvPr/>
        </p:nvSpPr>
        <p:spPr>
          <a:xfrm>
            <a:off x="787161" y="1307187"/>
            <a:ext cx="135349" cy="349057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48" name="path 48"/>
          <p:cNvSpPr/>
          <p:nvPr/>
        </p:nvSpPr>
        <p:spPr>
          <a:xfrm>
            <a:off x="787161" y="1741729"/>
            <a:ext cx="135349" cy="349057"/>
          </a:xfrm>
          <a:custGeom>
            <a:avLst/>
            <a:gdLst/>
            <a:ahLst/>
            <a:cxnLst/>
            <a:rect l="0" t="0" r="0" b="0"/>
            <a:pathLst>
              <a:path w="213" h="549">
                <a:moveTo>
                  <a:pt x="207" y="544"/>
                </a:moveTo>
                <a:lnTo>
                  <a:pt x="106" y="544"/>
                </a:lnTo>
                <a:moveTo>
                  <a:pt x="207" y="409"/>
                </a:moveTo>
                <a:lnTo>
                  <a:pt x="106" y="409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0" name="path 50"/>
          <p:cNvSpPr/>
          <p:nvPr/>
        </p:nvSpPr>
        <p:spPr>
          <a:xfrm>
            <a:off x="787161" y="872645"/>
            <a:ext cx="135349" cy="356182"/>
          </a:xfrm>
          <a:custGeom>
            <a:avLst/>
            <a:gdLst/>
            <a:ahLst/>
            <a:cxnLst/>
            <a:rect l="0" t="0" r="0" b="0"/>
            <a:pathLst>
              <a:path w="213" h="560">
                <a:moveTo>
                  <a:pt x="207" y="555"/>
                </a:moveTo>
                <a:lnTo>
                  <a:pt x="106" y="555"/>
                </a:lnTo>
                <a:moveTo>
                  <a:pt x="207" y="420"/>
                </a:moveTo>
                <a:lnTo>
                  <a:pt x="106" y="420"/>
                </a:lnTo>
                <a:moveTo>
                  <a:pt x="207" y="274"/>
                </a:moveTo>
                <a:lnTo>
                  <a:pt x="106" y="274"/>
                </a:lnTo>
                <a:moveTo>
                  <a:pt x="207" y="140"/>
                </a:moveTo>
                <a:lnTo>
                  <a:pt x="106" y="140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2" name="path 52"/>
          <p:cNvSpPr/>
          <p:nvPr/>
        </p:nvSpPr>
        <p:spPr>
          <a:xfrm>
            <a:off x="851274" y="787162"/>
            <a:ext cx="71236" cy="3120152"/>
          </a:xfrm>
          <a:custGeom>
            <a:avLst/>
            <a:gdLst/>
            <a:ahLst/>
            <a:cxnLst/>
            <a:rect l="0" t="0" r="0" b="0"/>
            <a:pathLst>
              <a:path w="112" h="4913">
                <a:moveTo>
                  <a:pt x="106" y="5"/>
                </a:moveTo>
                <a:lnTo>
                  <a:pt x="5" y="5"/>
                </a:lnTo>
                <a:moveTo>
                  <a:pt x="106" y="4908"/>
                </a:moveTo>
                <a:lnTo>
                  <a:pt x="10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textbox 54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6" name="textbox 56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58" name="picture 5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60" name="picture 6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62" name="textbox 62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4" name="textbox 64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6" name="textbox 66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8" name="path 68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path 78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0" name="path 80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 82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 84"/>
          <p:cNvSpPr/>
          <p:nvPr/>
        </p:nvSpPr>
        <p:spPr>
          <a:xfrm>
            <a:off x="3095220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 86"/>
          <p:cNvSpPr/>
          <p:nvPr/>
        </p:nvSpPr>
        <p:spPr>
          <a:xfrm>
            <a:off x="3095220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 88"/>
          <p:cNvSpPr/>
          <p:nvPr/>
        </p:nvSpPr>
        <p:spPr>
          <a:xfrm>
            <a:off x="3095220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3095220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path 92"/>
          <p:cNvSpPr/>
          <p:nvPr/>
        </p:nvSpPr>
        <p:spPr>
          <a:xfrm>
            <a:off x="3095220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path 94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path 96"/>
          <p:cNvSpPr/>
          <p:nvPr/>
        </p:nvSpPr>
        <p:spPr>
          <a:xfrm>
            <a:off x="3152209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textbox 98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textbox 100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02" name="picture 10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104" name="textbox 104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6" name="textbox 106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8" name="textbox 108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0" name="rect 110"/>
          <p:cNvSpPr/>
          <p:nvPr/>
        </p:nvSpPr>
        <p:spPr>
          <a:xfrm>
            <a:off x="3382804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2" name="rect 112"/>
          <p:cNvSpPr/>
          <p:nvPr/>
        </p:nvSpPr>
        <p:spPr>
          <a:xfrm>
            <a:off x="1050796" y="7538984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4" name="rect 114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textbox 116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18" name="textbox 118"/>
          <p:cNvSpPr/>
          <p:nvPr/>
        </p:nvSpPr>
        <p:spPr>
          <a:xfrm>
            <a:off x="3379499" y="7540575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20" name="textbox 120"/>
          <p:cNvSpPr/>
          <p:nvPr/>
        </p:nvSpPr>
        <p:spPr>
          <a:xfrm>
            <a:off x="1047510" y="7544693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Q5NjlkZjQ4NmY2YmRlZWY0ZDc5MDc2N2QzMGZhMDQifQ=="/>
</p:tagLst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55</Words>
  <Application>WPS 演示</Application>
  <PresentationFormat/>
  <Paragraphs>19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Arial</vt:lpstr>
      <vt:lpstr>微软雅黑</vt:lpstr>
      <vt:lpstr>Arial Unicode MS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格林</cp:lastModifiedBy>
  <cp:revision>2</cp:revision>
  <dcterms:created xsi:type="dcterms:W3CDTF">2024-03-05T14:44:00Z</dcterms:created>
  <dcterms:modified xsi:type="dcterms:W3CDTF">2024-09-07T16:0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kw</vt:lpwstr>
  </property>
  <property fmtid="{D5CDD505-2E9C-101B-9397-08002B2CF9AE}" pid="3" name="Created">
    <vt:filetime>2024-03-06T06:33:47Z</vt:filetime>
  </property>
  <property fmtid="{D5CDD505-2E9C-101B-9397-08002B2CF9AE}" pid="4" name="ICV">
    <vt:lpwstr>8E1D275A6F3E46EBA298B6183D283DDE_12</vt:lpwstr>
  </property>
  <property fmtid="{D5CDD505-2E9C-101B-9397-08002B2CF9AE}" pid="5" name="KSOProductBuildVer">
    <vt:lpwstr>2052-12.1.0.16910</vt:lpwstr>
  </property>
</Properties>
</file>